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2084" y="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62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12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19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3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85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2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72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04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8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3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864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3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image" Target="../media/image15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4.tif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image" Target="../media/image13.tiff"/><Relationship Id="rId30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21B73A4-1914-4DEB-BF48-5D49FF178252}"/>
              </a:ext>
            </a:extLst>
          </p:cNvPr>
          <p:cNvSpPr/>
          <p:nvPr/>
        </p:nvSpPr>
        <p:spPr>
          <a:xfrm>
            <a:off x="91356" y="6433780"/>
            <a:ext cx="6616424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re S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and PD included mitochondrial dynamic perturbated models present metabolomics reprogramming accompanied by Hsp22 induction.</a:t>
            </a:r>
          </a:p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2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ib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ontrol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p1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f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tested by RT-PCR separately. 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3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tested by WB and quantification of mitochondrial CI and CII function tested in thorax tissue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glycolytic marker of mitochondrial dynamics modulated mRNA expression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lactate level tested separately in each group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reenings of essential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ps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via RT-PCR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f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p1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in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MHC-Gal4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ontrols tested by RT-PCR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3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expression tested by WB  and quantification of mitochondrial CI and CII function tested in thorax tissue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glycolytic marker of mitochondrial dynamics modulated mRNA expression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lactate level tested separately in each group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reenings of essential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p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via RT-PCR. </a:t>
            </a:r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 values are means ± SD of at least three independent experiments. Student's t test (unpaired); *p&lt; 0.05, **p&lt; 0.01, **p&lt; 0.001.</a:t>
            </a:r>
          </a:p>
          <a:p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87087DD-997B-4201-807F-7FD242CA12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3459255"/>
              </p:ext>
            </p:extLst>
          </p:nvPr>
        </p:nvGraphicFramePr>
        <p:xfrm>
          <a:off x="4404455" y="3371645"/>
          <a:ext cx="1405030" cy="11596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2" name="Prism 8" r:id="rId3" imgW="3588292" imgH="2962748" progId="Prism8.Document">
                  <p:embed/>
                </p:oleObj>
              </mc:Choice>
              <mc:Fallback>
                <p:oleObj name="Prism 8" r:id="rId3" imgW="3588292" imgH="2962748" progId="Prism8.Document">
                  <p:embed/>
                  <p:pic>
                    <p:nvPicPr>
                      <p:cNvPr id="102" name="Object 2">
                        <a:extLst>
                          <a:ext uri="{FF2B5EF4-FFF2-40B4-BE49-F238E27FC236}">
                            <a16:creationId xmlns:a16="http://schemas.microsoft.com/office/drawing/2014/main" id="{287087DD-997B-4201-807F-7FD242CA12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04455" y="3371645"/>
                        <a:ext cx="1405030" cy="11596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BA719D2-B914-422C-BCC4-97929F9216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6716984"/>
              </p:ext>
            </p:extLst>
          </p:nvPr>
        </p:nvGraphicFramePr>
        <p:xfrm>
          <a:off x="2459082" y="4960164"/>
          <a:ext cx="893081" cy="1457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3" name="Prism 8" r:id="rId5" imgW="2085672" imgH="3406260" progId="Prism8.Document">
                  <p:embed/>
                </p:oleObj>
              </mc:Choice>
              <mc:Fallback>
                <p:oleObj name="Prism 8" r:id="rId5" imgW="2085672" imgH="3406260" progId="Prism8.Document">
                  <p:embed/>
                  <p:pic>
                    <p:nvPicPr>
                      <p:cNvPr id="103" name="Object 3">
                        <a:extLst>
                          <a:ext uri="{FF2B5EF4-FFF2-40B4-BE49-F238E27FC236}">
                            <a16:creationId xmlns:a16="http://schemas.microsoft.com/office/drawing/2014/main" id="{ABA719D2-B914-422C-BCC4-97929F9216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59082" y="4960164"/>
                        <a:ext cx="893081" cy="1457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790E83D-C41A-4BC6-9654-3CA00888F3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8346371"/>
              </p:ext>
            </p:extLst>
          </p:nvPr>
        </p:nvGraphicFramePr>
        <p:xfrm>
          <a:off x="440299" y="4874272"/>
          <a:ext cx="1831810" cy="1405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4" name="Prism 8" r:id="rId7" imgW="4484105" imgH="3439740" progId="Prism8.Document">
                  <p:embed/>
                </p:oleObj>
              </mc:Choice>
              <mc:Fallback>
                <p:oleObj name="Prism 8" r:id="rId7" imgW="4484105" imgH="3439740" progId="Prism8.Document">
                  <p:embed/>
                  <p:pic>
                    <p:nvPicPr>
                      <p:cNvPr id="104" name="Object 4">
                        <a:extLst>
                          <a:ext uri="{FF2B5EF4-FFF2-40B4-BE49-F238E27FC236}">
                            <a16:creationId xmlns:a16="http://schemas.microsoft.com/office/drawing/2014/main" id="{A790E83D-C41A-4BC6-9654-3CA00888F3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0299" y="4874272"/>
                        <a:ext cx="1831810" cy="1405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BF347A9-436B-4689-BA76-AB7D4D0792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8778163"/>
              </p:ext>
            </p:extLst>
          </p:nvPr>
        </p:nvGraphicFramePr>
        <p:xfrm>
          <a:off x="3425715" y="3537825"/>
          <a:ext cx="661987" cy="1157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5" name="Prism 8" r:id="rId9" imgW="1777950" imgH="3101346" progId="Prism8.Document">
                  <p:embed/>
                </p:oleObj>
              </mc:Choice>
              <mc:Fallback>
                <p:oleObj name="Prism 8" r:id="rId9" imgW="1777950" imgH="3101346" progId="Prism8.Document">
                  <p:embed/>
                  <p:pic>
                    <p:nvPicPr>
                      <p:cNvPr id="105" name="Object 5">
                        <a:extLst>
                          <a:ext uri="{FF2B5EF4-FFF2-40B4-BE49-F238E27FC236}">
                            <a16:creationId xmlns:a16="http://schemas.microsoft.com/office/drawing/2014/main" id="{0BF347A9-436B-4689-BA76-AB7D4D0792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25715" y="3537825"/>
                        <a:ext cx="661987" cy="1157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343447" y="185870"/>
            <a:ext cx="26000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b="1" dirty="0"/>
              <a:t>A</a:t>
            </a:r>
          </a:p>
        </p:txBody>
      </p:sp>
      <p:graphicFrame>
        <p:nvGraphicFramePr>
          <p:cNvPr id="8" name="对象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2539716"/>
              </p:ext>
            </p:extLst>
          </p:nvPr>
        </p:nvGraphicFramePr>
        <p:xfrm>
          <a:off x="3735180" y="1523063"/>
          <a:ext cx="1866611" cy="1381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6" name="Prism 8" r:id="rId11" imgW="3900333" imgH="2886429" progId="Prism8.Document">
                  <p:embed/>
                </p:oleObj>
              </mc:Choice>
              <mc:Fallback>
                <p:oleObj name="Prism 8" r:id="rId11" imgW="3900333" imgH="2886429" progId="Prism8.Document">
                  <p:embed/>
                  <p:pic>
                    <p:nvPicPr>
                      <p:cNvPr id="108" name="对象 10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735180" y="1523063"/>
                        <a:ext cx="1866611" cy="13811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630230"/>
              </p:ext>
            </p:extLst>
          </p:nvPr>
        </p:nvGraphicFramePr>
        <p:xfrm>
          <a:off x="3656594" y="4730320"/>
          <a:ext cx="1913721" cy="14160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7" name="Prism 8" r:id="rId13" imgW="3900333" imgH="2886429" progId="Prism8.Document">
                  <p:embed/>
                </p:oleObj>
              </mc:Choice>
              <mc:Fallback>
                <p:oleObj name="Prism 8" r:id="rId13" imgW="3900333" imgH="2886429" progId="Prism8.Document">
                  <p:embed/>
                  <p:pic>
                    <p:nvPicPr>
                      <p:cNvPr id="109" name="对象 10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56594" y="4730320"/>
                        <a:ext cx="1913721" cy="14160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7907259"/>
              </p:ext>
            </p:extLst>
          </p:nvPr>
        </p:nvGraphicFramePr>
        <p:xfrm>
          <a:off x="4406880" y="314824"/>
          <a:ext cx="1402605" cy="12469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8" name="Prism 8" r:id="rId15" imgW="3332037" imgH="2962748" progId="Prism8.Document">
                  <p:embed/>
                </p:oleObj>
              </mc:Choice>
              <mc:Fallback>
                <p:oleObj name="Prism 8" r:id="rId15" imgW="3332037" imgH="2962748" progId="Prism8.Document">
                  <p:embed/>
                  <p:pic>
                    <p:nvPicPr>
                      <p:cNvPr id="110" name="对象 109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406880" y="314824"/>
                        <a:ext cx="1402605" cy="12469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0206690"/>
              </p:ext>
            </p:extLst>
          </p:nvPr>
        </p:nvGraphicFramePr>
        <p:xfrm>
          <a:off x="546555" y="274538"/>
          <a:ext cx="1192172" cy="11824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69" name="Prism 8" r:id="rId17" imgW="2910224" imgH="2886429" progId="Prism8.Document">
                  <p:embed/>
                </p:oleObj>
              </mc:Choice>
              <mc:Fallback>
                <p:oleObj name="Prism 8" r:id="rId17" imgW="2910224" imgH="2886429" progId="Prism8.Document">
                  <p:embed/>
                  <p:pic>
                    <p:nvPicPr>
                      <p:cNvPr id="111" name="对象 110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46555" y="274538"/>
                        <a:ext cx="1192172" cy="11824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1885274" y="189023"/>
            <a:ext cx="25519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B</a:t>
            </a:r>
            <a:endParaRPr lang="en-US" sz="975" b="1" dirty="0"/>
          </a:p>
        </p:txBody>
      </p:sp>
      <p:sp>
        <p:nvSpPr>
          <p:cNvPr id="13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147908" y="1622110"/>
            <a:ext cx="26321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D</a:t>
            </a:r>
            <a:endParaRPr lang="en-US" sz="975" b="1" dirty="0"/>
          </a:p>
        </p:txBody>
      </p:sp>
      <p:graphicFrame>
        <p:nvGraphicFramePr>
          <p:cNvPr id="14" name="对象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7398905"/>
              </p:ext>
            </p:extLst>
          </p:nvPr>
        </p:nvGraphicFramePr>
        <p:xfrm>
          <a:off x="3168877" y="268061"/>
          <a:ext cx="1177925" cy="127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70" name="Prism 8" r:id="rId19" imgW="2663326" imgH="2886429" progId="Prism8.Document">
                  <p:embed/>
                </p:oleObj>
              </mc:Choice>
              <mc:Fallback>
                <p:oleObj name="Prism 8" r:id="rId19" imgW="2663326" imgH="2886429" progId="Prism8.Document">
                  <p:embed/>
                  <p:pic>
                    <p:nvPicPr>
                      <p:cNvPr id="115" name="对象 114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168877" y="268061"/>
                        <a:ext cx="1177925" cy="127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4148126"/>
              </p:ext>
            </p:extLst>
          </p:nvPr>
        </p:nvGraphicFramePr>
        <p:xfrm>
          <a:off x="2295511" y="1588276"/>
          <a:ext cx="1104057" cy="1337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71" name="Prism 8" r:id="rId21" imgW="2390515" imgH="2895429" progId="Prism8.Document">
                  <p:embed/>
                </p:oleObj>
              </mc:Choice>
              <mc:Fallback>
                <p:oleObj name="Prism 8" r:id="rId21" imgW="2390515" imgH="2895429" progId="Prism8.Document">
                  <p:embed/>
                  <p:pic>
                    <p:nvPicPr>
                      <p:cNvPr id="122" name="对象 121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295511" y="1588276"/>
                        <a:ext cx="1104057" cy="13371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353607" y="1568782"/>
            <a:ext cx="25039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C</a:t>
            </a:r>
            <a:endParaRPr lang="en-US" sz="975" b="1" dirty="0"/>
          </a:p>
        </p:txBody>
      </p:sp>
      <p:graphicFrame>
        <p:nvGraphicFramePr>
          <p:cNvPr id="17" name="对象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843129"/>
              </p:ext>
            </p:extLst>
          </p:nvPr>
        </p:nvGraphicFramePr>
        <p:xfrm>
          <a:off x="490539" y="1602865"/>
          <a:ext cx="1527479" cy="1395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72" name="Prism 8" r:id="rId23" imgW="3557700" imgH="3248943" progId="Prism8.Document">
                  <p:embed/>
                </p:oleObj>
              </mc:Choice>
              <mc:Fallback>
                <p:oleObj name="Prism 8" r:id="rId23" imgW="3557700" imgH="3248943" progId="Prism8.Document">
                  <p:embed/>
                  <p:pic>
                    <p:nvPicPr>
                      <p:cNvPr id="124" name="对象 123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90539" y="1602865"/>
                        <a:ext cx="1527479" cy="13952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3594553" y="1557219"/>
            <a:ext cx="24558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E</a:t>
            </a:r>
            <a:endParaRPr lang="en-US" sz="975" b="1" dirty="0"/>
          </a:p>
        </p:txBody>
      </p:sp>
      <p:sp>
        <p:nvSpPr>
          <p:cNvPr id="19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50076" y="3273997"/>
            <a:ext cx="24558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F</a:t>
            </a:r>
            <a:endParaRPr lang="en-US" sz="975" b="1" dirty="0"/>
          </a:p>
        </p:txBody>
      </p:sp>
      <p:sp>
        <p:nvSpPr>
          <p:cNvPr id="20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004303" y="3230858"/>
            <a:ext cx="264816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G</a:t>
            </a:r>
            <a:endParaRPr lang="en-US" sz="975" b="1" dirty="0"/>
          </a:p>
        </p:txBody>
      </p:sp>
      <p:sp>
        <p:nvSpPr>
          <p:cNvPr id="21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96895" y="4790208"/>
            <a:ext cx="264816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H</a:t>
            </a:r>
            <a:endParaRPr lang="en-US" sz="975" b="1" dirty="0"/>
          </a:p>
        </p:txBody>
      </p:sp>
      <p:sp>
        <p:nvSpPr>
          <p:cNvPr id="2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236450" y="4788299"/>
            <a:ext cx="21833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I</a:t>
            </a:r>
            <a:endParaRPr lang="en-US" sz="975" b="1" dirty="0"/>
          </a:p>
        </p:txBody>
      </p:sp>
      <p:sp>
        <p:nvSpPr>
          <p:cNvPr id="23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3560262" y="4772801"/>
            <a:ext cx="22634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J</a:t>
            </a:r>
            <a:endParaRPr lang="en-US" sz="975" b="1" dirty="0"/>
          </a:p>
        </p:txBody>
      </p:sp>
      <p:graphicFrame>
        <p:nvGraphicFramePr>
          <p:cNvPr id="24" name="对象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5913053"/>
              </p:ext>
            </p:extLst>
          </p:nvPr>
        </p:nvGraphicFramePr>
        <p:xfrm>
          <a:off x="563435" y="3380903"/>
          <a:ext cx="1352285" cy="11205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73" name="Prism 8" r:id="rId25" imgW="3482839" imgH="2886429" progId="Prism8.Document">
                  <p:embed/>
                </p:oleObj>
              </mc:Choice>
              <mc:Fallback>
                <p:oleObj name="Prism 8" r:id="rId25" imgW="3482839" imgH="2886429" progId="Prism8.Document">
                  <p:embed/>
                  <p:pic>
                    <p:nvPicPr>
                      <p:cNvPr id="7" name="对象 6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63435" y="3380903"/>
                        <a:ext cx="1352285" cy="11205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5" name="组合 24"/>
          <p:cNvGrpSpPr/>
          <p:nvPr/>
        </p:nvGrpSpPr>
        <p:grpSpPr>
          <a:xfrm>
            <a:off x="2027529" y="3287884"/>
            <a:ext cx="1196120" cy="1085468"/>
            <a:chOff x="10336497" y="3089107"/>
            <a:chExt cx="1196120" cy="1085468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18" t="39302" r="73809" b="51078"/>
            <a:stretch/>
          </p:blipFill>
          <p:spPr>
            <a:xfrm>
              <a:off x="10807464" y="3768220"/>
              <a:ext cx="535698" cy="171283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02" t="64822" r="73331" b="23374"/>
            <a:stretch/>
          </p:blipFill>
          <p:spPr>
            <a:xfrm>
              <a:off x="10807465" y="3538650"/>
              <a:ext cx="535697" cy="179072"/>
            </a:xfrm>
            <a:prstGeom prst="rect">
              <a:avLst/>
            </a:prstGeom>
          </p:spPr>
        </p:pic>
        <p:sp>
          <p:nvSpPr>
            <p:cNvPr id="28" name="Rectangle 38">
              <a:extLst>
                <a:ext uri="{FF2B5EF4-FFF2-40B4-BE49-F238E27FC236}">
                  <a16:creationId xmlns:a16="http://schemas.microsoft.com/office/drawing/2014/main" id="{1BD5528D-8822-4E29-AF18-1F8B3B491C5F}"/>
                </a:ext>
              </a:extLst>
            </p:cNvPr>
            <p:cNvSpPr/>
            <p:nvPr/>
          </p:nvSpPr>
          <p:spPr>
            <a:xfrm>
              <a:off x="10803162" y="3543338"/>
              <a:ext cx="540000" cy="1750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  <p:sp>
          <p:nvSpPr>
            <p:cNvPr id="29" name="TextBox 42">
              <a:extLst>
                <a:ext uri="{FF2B5EF4-FFF2-40B4-BE49-F238E27FC236}">
                  <a16:creationId xmlns:a16="http://schemas.microsoft.com/office/drawing/2014/main" id="{53CB33C4-1CA8-4D5D-9805-39C06E3719CF}"/>
                </a:ext>
              </a:extLst>
            </p:cNvPr>
            <p:cNvSpPr txBox="1"/>
            <p:nvPr/>
          </p:nvSpPr>
          <p:spPr>
            <a:xfrm>
              <a:off x="10374717" y="3755046"/>
              <a:ext cx="561727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43">
              <a:extLst>
                <a:ext uri="{FF2B5EF4-FFF2-40B4-BE49-F238E27FC236}">
                  <a16:creationId xmlns:a16="http://schemas.microsoft.com/office/drawing/2014/main" id="{3CF2AE7D-E0F0-40C1-B362-EE1144AC8168}"/>
                </a:ext>
              </a:extLst>
            </p:cNvPr>
            <p:cNvSpPr txBox="1"/>
            <p:nvPr/>
          </p:nvSpPr>
          <p:spPr>
            <a:xfrm>
              <a:off x="10336497" y="3533828"/>
              <a:ext cx="590776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FS3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1" name="Group 44">
              <a:extLst>
                <a:ext uri="{FF2B5EF4-FFF2-40B4-BE49-F238E27FC236}">
                  <a16:creationId xmlns:a16="http://schemas.microsoft.com/office/drawing/2014/main" id="{47F6E533-9DA0-423C-B9C9-3BA2270B3BD5}"/>
                </a:ext>
              </a:extLst>
            </p:cNvPr>
            <p:cNvGrpSpPr/>
            <p:nvPr/>
          </p:nvGrpSpPr>
          <p:grpSpPr>
            <a:xfrm>
              <a:off x="10923798" y="3089107"/>
              <a:ext cx="453362" cy="530158"/>
              <a:chOff x="1159462" y="2259360"/>
              <a:chExt cx="557984" cy="652503"/>
            </a:xfrm>
          </p:grpSpPr>
          <p:sp>
            <p:nvSpPr>
              <p:cNvPr id="34" name="TextBox 45">
                <a:extLst>
                  <a:ext uri="{FF2B5EF4-FFF2-40B4-BE49-F238E27FC236}">
                    <a16:creationId xmlns:a16="http://schemas.microsoft.com/office/drawing/2014/main" id="{1AE6A25C-CE0F-44F7-B548-118BE5EC11B0}"/>
                  </a:ext>
                </a:extLst>
              </p:cNvPr>
              <p:cNvSpPr txBox="1"/>
              <p:nvPr/>
            </p:nvSpPr>
            <p:spPr>
              <a:xfrm rot="18600000">
                <a:off x="1012003" y="2513516"/>
                <a:ext cx="531670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46">
                <a:extLst>
                  <a:ext uri="{FF2B5EF4-FFF2-40B4-BE49-F238E27FC236}">
                    <a16:creationId xmlns:a16="http://schemas.microsoft.com/office/drawing/2014/main" id="{1D7E3C2A-3F8A-4246-943E-B9AD7628C423}"/>
                  </a:ext>
                </a:extLst>
              </p:cNvPr>
              <p:cNvSpPr txBox="1"/>
              <p:nvPr/>
            </p:nvSpPr>
            <p:spPr>
              <a:xfrm rot="18600000">
                <a:off x="1272819" y="2467236"/>
                <a:ext cx="652503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2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10728416" y="3948070"/>
              <a:ext cx="804201" cy="2265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Gal4&gt;</a:t>
              </a:r>
            </a:p>
          </p:txBody>
        </p:sp>
        <p:sp>
          <p:nvSpPr>
            <p:cNvPr id="33" name="Rectangle 41">
              <a:extLst>
                <a:ext uri="{FF2B5EF4-FFF2-40B4-BE49-F238E27FC236}">
                  <a16:creationId xmlns:a16="http://schemas.microsoft.com/office/drawing/2014/main" id="{2144A46F-E0EB-4B36-9450-E2F911D731CA}"/>
                </a:ext>
              </a:extLst>
            </p:cNvPr>
            <p:cNvSpPr/>
            <p:nvPr/>
          </p:nvSpPr>
          <p:spPr>
            <a:xfrm>
              <a:off x="10803162" y="3764455"/>
              <a:ext cx="540000" cy="1750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1943375" y="254481"/>
            <a:ext cx="1304721" cy="1034698"/>
            <a:chOff x="15639932" y="317612"/>
            <a:chExt cx="1304721" cy="1034698"/>
          </a:xfrm>
        </p:grpSpPr>
        <p:pic>
          <p:nvPicPr>
            <p:cNvPr id="37" name="Picture 3" descr="F:\wzw\形态照片\FIG2-0001036_01 actin-2.tif"/>
            <p:cNvPicPr>
              <a:picLocks noChangeAspect="1"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09" t="33968" r="64019" b="57782"/>
            <a:stretch/>
          </p:blipFill>
          <p:spPr bwMode="auto">
            <a:xfrm>
              <a:off x="16087981" y="997286"/>
              <a:ext cx="539999" cy="17072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8" name="Picture 3" descr="F:\wzw\形态照片\FIG2-0001036_01 actin-2.tif"/>
            <p:cNvPicPr>
              <a:picLocks noChangeAspect="1" noChangeArrowheads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35" t="50903" r="63418" b="35779"/>
            <a:stretch/>
          </p:blipFill>
          <p:spPr bwMode="auto">
            <a:xfrm>
              <a:off x="16087981" y="771843"/>
              <a:ext cx="544543" cy="17504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1BD5528D-8822-4E29-AF18-1F8B3B491C5F}"/>
                </a:ext>
              </a:extLst>
            </p:cNvPr>
            <p:cNvSpPr/>
            <p:nvPr/>
          </p:nvSpPr>
          <p:spPr>
            <a:xfrm>
              <a:off x="16087981" y="771843"/>
              <a:ext cx="540000" cy="1750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  <p:sp>
          <p:nvSpPr>
            <p:cNvPr id="40" name="TextBox 42">
              <a:extLst>
                <a:ext uri="{FF2B5EF4-FFF2-40B4-BE49-F238E27FC236}">
                  <a16:creationId xmlns:a16="http://schemas.microsoft.com/office/drawing/2014/main" id="{53CB33C4-1CA8-4D5D-9805-39C06E3719CF}"/>
                </a:ext>
              </a:extLst>
            </p:cNvPr>
            <p:cNvSpPr txBox="1"/>
            <p:nvPr/>
          </p:nvSpPr>
          <p:spPr>
            <a:xfrm>
              <a:off x="15652143" y="976051"/>
              <a:ext cx="561727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3">
              <a:extLst>
                <a:ext uri="{FF2B5EF4-FFF2-40B4-BE49-F238E27FC236}">
                  <a16:creationId xmlns:a16="http://schemas.microsoft.com/office/drawing/2014/main" id="{3CF2AE7D-E0F0-40C1-B362-EE1144AC8168}"/>
                </a:ext>
              </a:extLst>
            </p:cNvPr>
            <p:cNvSpPr txBox="1"/>
            <p:nvPr/>
          </p:nvSpPr>
          <p:spPr>
            <a:xfrm>
              <a:off x="15639932" y="771420"/>
              <a:ext cx="590776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FS3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2" name="Group 44">
              <a:extLst>
                <a:ext uri="{FF2B5EF4-FFF2-40B4-BE49-F238E27FC236}">
                  <a16:creationId xmlns:a16="http://schemas.microsoft.com/office/drawing/2014/main" id="{47F6E533-9DA0-423C-B9C9-3BA2270B3BD5}"/>
                </a:ext>
              </a:extLst>
            </p:cNvPr>
            <p:cNvGrpSpPr/>
            <p:nvPr/>
          </p:nvGrpSpPr>
          <p:grpSpPr>
            <a:xfrm>
              <a:off x="16208617" y="317612"/>
              <a:ext cx="453360" cy="530158"/>
              <a:chOff x="1159462" y="2259360"/>
              <a:chExt cx="557982" cy="652503"/>
            </a:xfrm>
          </p:grpSpPr>
          <p:sp>
            <p:nvSpPr>
              <p:cNvPr id="45" name="TextBox 45">
                <a:extLst>
                  <a:ext uri="{FF2B5EF4-FFF2-40B4-BE49-F238E27FC236}">
                    <a16:creationId xmlns:a16="http://schemas.microsoft.com/office/drawing/2014/main" id="{1AE6A25C-CE0F-44F7-B548-118BE5EC11B0}"/>
                  </a:ext>
                </a:extLst>
              </p:cNvPr>
              <p:cNvSpPr txBox="1"/>
              <p:nvPr/>
            </p:nvSpPr>
            <p:spPr>
              <a:xfrm rot="18600000">
                <a:off x="1012003" y="2513516"/>
                <a:ext cx="531670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6">
                <a:extLst>
                  <a:ext uri="{FF2B5EF4-FFF2-40B4-BE49-F238E27FC236}">
                    <a16:creationId xmlns:a16="http://schemas.microsoft.com/office/drawing/2014/main" id="{1D7E3C2A-3F8A-4246-943E-B9AD7628C423}"/>
                  </a:ext>
                </a:extLst>
              </p:cNvPr>
              <p:cNvSpPr txBox="1"/>
              <p:nvPr/>
            </p:nvSpPr>
            <p:spPr>
              <a:xfrm rot="18600000">
                <a:off x="1272817" y="2467236"/>
                <a:ext cx="652503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s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12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3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16140452" y="1159950"/>
              <a:ext cx="80420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rib</a:t>
              </a:r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/-</a:t>
              </a: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2144A46F-E0EB-4B36-9450-E2F911D731CA}"/>
                </a:ext>
              </a:extLst>
            </p:cNvPr>
            <p:cNvSpPr/>
            <p:nvPr/>
          </p:nvSpPr>
          <p:spPr>
            <a:xfrm>
              <a:off x="16087981" y="992960"/>
              <a:ext cx="540000" cy="1750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</p:grpSp>
    </p:spTree>
    <p:extLst>
      <p:ext uri="{BB962C8B-B14F-4D97-AF65-F5344CB8AC3E}">
        <p14:creationId xmlns:p14="http://schemas.microsoft.com/office/powerpoint/2010/main" val="2960129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2</TotalTime>
  <Words>231</Words>
  <Application>Microsoft Office PowerPoint</Application>
  <PresentationFormat>A4 纸张(210x297 毫米)</PresentationFormat>
  <Paragraphs>22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Y</dc:creator>
  <cp:lastModifiedBy>li qinghua</cp:lastModifiedBy>
  <cp:revision>45</cp:revision>
  <dcterms:created xsi:type="dcterms:W3CDTF">2020-10-27T08:03:31Z</dcterms:created>
  <dcterms:modified xsi:type="dcterms:W3CDTF">2020-11-23T06:42:08Z</dcterms:modified>
</cp:coreProperties>
</file>